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80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74" r:id="rId11"/>
    <p:sldId id="275" r:id="rId12"/>
    <p:sldId id="276" r:id="rId13"/>
    <p:sldId id="277" r:id="rId14"/>
    <p:sldId id="273" r:id="rId15"/>
    <p:sldId id="269" r:id="rId16"/>
    <p:sldId id="272" r:id="rId17"/>
    <p:sldId id="278" r:id="rId18"/>
    <p:sldId id="279" r:id="rId19"/>
    <p:sldId id="271" r:id="rId20"/>
    <p:sldId id="270" r:id="rId21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01"/>
    <p:restoredTop sz="96197"/>
  </p:normalViewPr>
  <p:slideViewPr>
    <p:cSldViewPr snapToGrid="0" snapToObjects="1">
      <p:cViewPr varScale="1">
        <p:scale>
          <a:sx n="70" d="100"/>
          <a:sy n="70" d="100"/>
        </p:scale>
        <p:origin x="50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kiraokada\Documents\&#21407;&#31295;:&#23398;&#20250;:&#35542;&#25991;\&#20182;&#12398;&#20808;&#29983;&#12398;&#35542;&#25991;\&#37329;&#23376;&#20808;&#29983;\20220707\data20220707r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/>
              <a:t>among patients aged </a:t>
            </a:r>
            <a:r>
              <a:rPr lang="ja-JP"/>
              <a:t>≥</a:t>
            </a:r>
            <a:r>
              <a:rPr lang="en-US"/>
              <a:t> 80 year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20:$C$28</c:f>
              <c:strCache>
                <c:ptCount val="9"/>
                <c:pt idx="0">
                  <c:v>Kidney failure or kidney replacement therapy receipt within 2 days</c:v>
                </c:pt>
                <c:pt idx="1">
                  <c:v>Body mass index decrease</c:v>
                </c:pt>
                <c:pt idx="2">
                  <c:v>NYHA Class IV (vs Class II)</c:v>
                </c:pt>
                <c:pt idx="3">
                  <c:v>Vasopressor use within 2 days</c:v>
                </c:pt>
                <c:pt idx="4">
                  <c:v>Failure to initiate enteral alimentation within 2 days</c:v>
                </c:pt>
                <c:pt idx="5">
                  <c:v>Impaired consciousness</c:v>
                </c:pt>
                <c:pt idx="6">
                  <c:v>Age increase</c:v>
                </c:pt>
                <c:pt idx="7">
                  <c:v>Absence of comorbid hypertension</c:v>
                </c:pt>
                <c:pt idx="8">
                  <c:v>Barthel index decrease</c:v>
                </c:pt>
              </c:strCache>
            </c:strRef>
          </c:cat>
          <c:val>
            <c:numRef>
              <c:f>Variableimp!$D$20:$D$28</c:f>
              <c:numCache>
                <c:formatCode>General</c:formatCode>
                <c:ptCount val="9"/>
                <c:pt idx="0">
                  <c:v>3.0255985966215166E-2</c:v>
                </c:pt>
                <c:pt idx="1">
                  <c:v>0.12079463204879146</c:v>
                </c:pt>
                <c:pt idx="2">
                  <c:v>0.20391451245665779</c:v>
                </c:pt>
                <c:pt idx="3">
                  <c:v>0.23088091842307104</c:v>
                </c:pt>
                <c:pt idx="4">
                  <c:v>0.24555360579067143</c:v>
                </c:pt>
                <c:pt idx="5">
                  <c:v>0.30135077440173275</c:v>
                </c:pt>
                <c:pt idx="6">
                  <c:v>0.30940930283874507</c:v>
                </c:pt>
                <c:pt idx="7">
                  <c:v>0.40884876202464582</c:v>
                </c:pt>
                <c:pt idx="8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86E-7046-BDD4-11B99068EF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57446992"/>
        <c:axId val="1757461136"/>
      </c:barChart>
      <c:catAx>
        <c:axId val="17574469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61136"/>
        <c:crosses val="autoZero"/>
        <c:auto val="1"/>
        <c:lblAlgn val="ctr"/>
        <c:lblOffset val="100"/>
        <c:noMultiLvlLbl val="0"/>
      </c:catAx>
      <c:valAx>
        <c:axId val="1757461136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46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/>
              <a:t>among patients aged &lt; 80 year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30:$C$39</c:f>
              <c:strCache>
                <c:ptCount val="10"/>
                <c:pt idx="0">
                  <c:v>Shock or ventricular fibrillation on admission</c:v>
                </c:pt>
                <c:pt idx="1">
                  <c:v>Kidney failure or kidney replacement therapy receipt within 2 days</c:v>
                </c:pt>
                <c:pt idx="2">
                  <c:v>Age increase</c:v>
                </c:pt>
                <c:pt idx="3">
                  <c:v>Failure to initiate enteral alimentation within 2 days</c:v>
                </c:pt>
                <c:pt idx="4">
                  <c:v>Body mass index decrease</c:v>
                </c:pt>
                <c:pt idx="5">
                  <c:v>NYHA Class IV (vs Class II)</c:v>
                </c:pt>
                <c:pt idx="6">
                  <c:v>Impaired consciousness</c:v>
                </c:pt>
                <c:pt idx="7">
                  <c:v>Vasopressor use within 2 days</c:v>
                </c:pt>
                <c:pt idx="8">
                  <c:v>Absence of comorbid hypertension</c:v>
                </c:pt>
                <c:pt idx="9">
                  <c:v>Barthel index decrease</c:v>
                </c:pt>
              </c:strCache>
            </c:strRef>
          </c:cat>
          <c:val>
            <c:numRef>
              <c:f>Variableimp!$D$30:$D$39</c:f>
              <c:numCache>
                <c:formatCode>General</c:formatCode>
                <c:ptCount val="10"/>
                <c:pt idx="0">
                  <c:v>2.4005519275748212E-2</c:v>
                </c:pt>
                <c:pt idx="1">
                  <c:v>8.9038509764679544E-2</c:v>
                </c:pt>
                <c:pt idx="2">
                  <c:v>9.778356640038785E-2</c:v>
                </c:pt>
                <c:pt idx="3">
                  <c:v>0.20402107637215303</c:v>
                </c:pt>
                <c:pt idx="4">
                  <c:v>0.25174379189072621</c:v>
                </c:pt>
                <c:pt idx="5">
                  <c:v>0.28825966359285343</c:v>
                </c:pt>
                <c:pt idx="6">
                  <c:v>0.32802277567936744</c:v>
                </c:pt>
                <c:pt idx="7">
                  <c:v>0.3863552386119451</c:v>
                </c:pt>
                <c:pt idx="8">
                  <c:v>0.78200389375596013</c:v>
                </c:pt>
                <c:pt idx="9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DB0-BC44-9194-5CE8735158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57452976"/>
        <c:axId val="1757452432"/>
      </c:barChart>
      <c:catAx>
        <c:axId val="17574529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2432"/>
        <c:crosses val="autoZero"/>
        <c:auto val="1"/>
        <c:lblAlgn val="ctr"/>
        <c:lblOffset val="100"/>
        <c:noMultiLvlLbl val="0"/>
      </c:catAx>
      <c:valAx>
        <c:axId val="1757452432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2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/>
              <a:t>among female patient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44:$C$53</c:f>
              <c:strCache>
                <c:ptCount val="10"/>
                <c:pt idx="0">
                  <c:v>Charlson comorbidity index</c:v>
                </c:pt>
                <c:pt idx="1">
                  <c:v>Kidney failure or kidney replacement therapy receipt within 2 days</c:v>
                </c:pt>
                <c:pt idx="2">
                  <c:v>Body mass index decrease</c:v>
                </c:pt>
                <c:pt idx="3">
                  <c:v>NYHA Class IV (vs Class II)</c:v>
                </c:pt>
                <c:pt idx="4">
                  <c:v>Vasopressor use within 2 days</c:v>
                </c:pt>
                <c:pt idx="5">
                  <c:v>Failure to initiate enteral alimentation within 2 days</c:v>
                </c:pt>
                <c:pt idx="6">
                  <c:v>Impaired consciousness</c:v>
                </c:pt>
                <c:pt idx="7">
                  <c:v>Absence of comorbid hypertension</c:v>
                </c:pt>
                <c:pt idx="8">
                  <c:v>Age increase</c:v>
                </c:pt>
                <c:pt idx="9">
                  <c:v>Barthel index decrease</c:v>
                </c:pt>
              </c:strCache>
            </c:strRef>
          </c:cat>
          <c:val>
            <c:numRef>
              <c:f>Variableimp!$D$44:$D$53</c:f>
              <c:numCache>
                <c:formatCode>General</c:formatCode>
                <c:ptCount val="10"/>
                <c:pt idx="0">
                  <c:v>3.7057230672475128E-2</c:v>
                </c:pt>
                <c:pt idx="1">
                  <c:v>3.8456448588538292E-2</c:v>
                </c:pt>
                <c:pt idx="2">
                  <c:v>0.13446271060347553</c:v>
                </c:pt>
                <c:pt idx="3">
                  <c:v>0.18292723009680567</c:v>
                </c:pt>
                <c:pt idx="4">
                  <c:v>0.19188835626384573</c:v>
                </c:pt>
                <c:pt idx="5">
                  <c:v>0.2622393185688377</c:v>
                </c:pt>
                <c:pt idx="6">
                  <c:v>0.26453459624380976</c:v>
                </c:pt>
                <c:pt idx="7">
                  <c:v>0.47295607795928929</c:v>
                </c:pt>
                <c:pt idx="8">
                  <c:v>0.79026147021362325</c:v>
                </c:pt>
                <c:pt idx="9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59F-5543-AA1E-21931535E9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57453520"/>
        <c:axId val="1757454608"/>
      </c:barChart>
      <c:catAx>
        <c:axId val="17574535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4608"/>
        <c:crosses val="autoZero"/>
        <c:auto val="1"/>
        <c:lblAlgn val="ctr"/>
        <c:lblOffset val="100"/>
        <c:noMultiLvlLbl val="0"/>
      </c:catAx>
      <c:valAx>
        <c:axId val="1757454608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3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/>
              <a:t>among male patient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60:$C$69</c:f>
              <c:strCache>
                <c:ptCount val="10"/>
                <c:pt idx="0">
                  <c:v>Shock or ventricular fibrillation on admission</c:v>
                </c:pt>
                <c:pt idx="1">
                  <c:v>Kidney failure or kidney replacement therapy receipt within 2 days</c:v>
                </c:pt>
                <c:pt idx="2">
                  <c:v>Failure to initiate enteral alimentation within 2 days</c:v>
                </c:pt>
                <c:pt idx="3">
                  <c:v>NYHA Class IV (vs Class II)</c:v>
                </c:pt>
                <c:pt idx="4">
                  <c:v>Body mass index decrease</c:v>
                </c:pt>
                <c:pt idx="5">
                  <c:v>Vasopressor use within 2 days</c:v>
                </c:pt>
                <c:pt idx="6">
                  <c:v>Impaired consciousness</c:v>
                </c:pt>
                <c:pt idx="7">
                  <c:v>Absence of comorbid hypertension</c:v>
                </c:pt>
                <c:pt idx="8">
                  <c:v>Age increase</c:v>
                </c:pt>
                <c:pt idx="9">
                  <c:v>Barthel index decrease</c:v>
                </c:pt>
              </c:strCache>
            </c:strRef>
          </c:cat>
          <c:val>
            <c:numRef>
              <c:f>Variableimp!$D$60:$D$69</c:f>
              <c:numCache>
                <c:formatCode>General</c:formatCode>
                <c:ptCount val="10"/>
                <c:pt idx="0">
                  <c:v>9.7835044861395871E-3</c:v>
                </c:pt>
                <c:pt idx="1">
                  <c:v>9.060944573129022E-2</c:v>
                </c:pt>
                <c:pt idx="2">
                  <c:v>0.22353528391031771</c:v>
                </c:pt>
                <c:pt idx="3">
                  <c:v>0.28696295176926745</c:v>
                </c:pt>
                <c:pt idx="4">
                  <c:v>0.32200494435145266</c:v>
                </c:pt>
                <c:pt idx="5">
                  <c:v>0.3363175691248898</c:v>
                </c:pt>
                <c:pt idx="6">
                  <c:v>0.36030175284516019</c:v>
                </c:pt>
                <c:pt idx="7">
                  <c:v>0.60324911948794413</c:v>
                </c:pt>
                <c:pt idx="8">
                  <c:v>0.76736789846933595</c:v>
                </c:pt>
                <c:pt idx="9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E51-594D-ABE9-F553A1C834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57455696"/>
        <c:axId val="1757447536"/>
      </c:barChart>
      <c:catAx>
        <c:axId val="17574556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47536"/>
        <c:crosses val="autoZero"/>
        <c:auto val="1"/>
        <c:lblAlgn val="ctr"/>
        <c:lblOffset val="100"/>
        <c:noMultiLvlLbl val="0"/>
      </c:catAx>
      <c:valAx>
        <c:axId val="1757447536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5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35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35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 sz="1350"/>
              <a:t> among patients with Barthel index ≥ 60</a:t>
            </a:r>
            <a:endParaRPr lang="ja-JP" sz="135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35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72:$C$79</c:f>
              <c:strCache>
                <c:ptCount val="8"/>
                <c:pt idx="0">
                  <c:v>Impaired consciousness</c:v>
                </c:pt>
                <c:pt idx="1">
                  <c:v>Failure to initiate enteral alimentation within 2 days</c:v>
                </c:pt>
                <c:pt idx="2">
                  <c:v>Body mass index decrease</c:v>
                </c:pt>
                <c:pt idx="3">
                  <c:v>Vasopressor use within 2 days</c:v>
                </c:pt>
                <c:pt idx="4">
                  <c:v>Barthel index decrease</c:v>
                </c:pt>
                <c:pt idx="5">
                  <c:v>NYHA Class IV (vs Class II)</c:v>
                </c:pt>
                <c:pt idx="6">
                  <c:v>Absence of comorbid hypertension</c:v>
                </c:pt>
                <c:pt idx="7">
                  <c:v>Age increase</c:v>
                </c:pt>
              </c:strCache>
            </c:strRef>
          </c:cat>
          <c:val>
            <c:numRef>
              <c:f>Variableimp!$D$72:$D$79</c:f>
              <c:numCache>
                <c:formatCode>General</c:formatCode>
                <c:ptCount val="8"/>
                <c:pt idx="0">
                  <c:v>0.32616934236672313</c:v>
                </c:pt>
                <c:pt idx="1">
                  <c:v>0.32867663562040567</c:v>
                </c:pt>
                <c:pt idx="2">
                  <c:v>0.35551927653129117</c:v>
                </c:pt>
                <c:pt idx="3">
                  <c:v>0.40055326342757058</c:v>
                </c:pt>
                <c:pt idx="4">
                  <c:v>0.44405357471885765</c:v>
                </c:pt>
                <c:pt idx="5">
                  <c:v>0.64019806752200781</c:v>
                </c:pt>
                <c:pt idx="6">
                  <c:v>0.76006631160970473</c:v>
                </c:pt>
                <c:pt idx="7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C55-3141-87C7-3A1B86DDDF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57448080"/>
        <c:axId val="1757454064"/>
      </c:barChart>
      <c:catAx>
        <c:axId val="17574480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4064"/>
        <c:crosses val="autoZero"/>
        <c:auto val="1"/>
        <c:lblAlgn val="ctr"/>
        <c:lblOffset val="100"/>
        <c:noMultiLvlLbl val="0"/>
      </c:catAx>
      <c:valAx>
        <c:axId val="1757454064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48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35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35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 sz="1350"/>
              <a:t>among patients with Barthel index &lt; 60 </a:t>
            </a:r>
            <a:endParaRPr lang="ja-JP" sz="135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35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86:$C$96</c:f>
              <c:strCache>
                <c:ptCount val="11"/>
                <c:pt idx="0">
                  <c:v>Shock or ventricular fibrillation on admission</c:v>
                </c:pt>
                <c:pt idx="1">
                  <c:v>Charlson comorbidity index</c:v>
                </c:pt>
                <c:pt idx="2">
                  <c:v>Kidney failure or kidney replacement therapy receipt within 2 days</c:v>
                </c:pt>
                <c:pt idx="3">
                  <c:v>NYHA Class IV (vs Class II)</c:v>
                </c:pt>
                <c:pt idx="4">
                  <c:v>Body mass index decrease</c:v>
                </c:pt>
                <c:pt idx="5">
                  <c:v>Failure to initiate enteral alimentation within 2 days</c:v>
                </c:pt>
                <c:pt idx="6">
                  <c:v>Vasopressor use within 2 days</c:v>
                </c:pt>
                <c:pt idx="7">
                  <c:v>Impaired consciousness</c:v>
                </c:pt>
                <c:pt idx="8">
                  <c:v>Barthel index decrease</c:v>
                </c:pt>
                <c:pt idx="9">
                  <c:v>Absence of comorbid hypertension</c:v>
                </c:pt>
                <c:pt idx="10">
                  <c:v>Age increase</c:v>
                </c:pt>
              </c:strCache>
            </c:strRef>
          </c:cat>
          <c:val>
            <c:numRef>
              <c:f>Variableimp!$D$86:$D$96</c:f>
              <c:numCache>
                <c:formatCode>General</c:formatCode>
                <c:ptCount val="11"/>
                <c:pt idx="0">
                  <c:v>2.0742886179967248E-2</c:v>
                </c:pt>
                <c:pt idx="1">
                  <c:v>5.9396653409006642E-2</c:v>
                </c:pt>
                <c:pt idx="2">
                  <c:v>8.0813667338530432E-2</c:v>
                </c:pt>
                <c:pt idx="3">
                  <c:v>0.15873396320019684</c:v>
                </c:pt>
                <c:pt idx="4">
                  <c:v>0.26079940901529197</c:v>
                </c:pt>
                <c:pt idx="5">
                  <c:v>0.27046976879691903</c:v>
                </c:pt>
                <c:pt idx="6">
                  <c:v>0.2970387169642183</c:v>
                </c:pt>
                <c:pt idx="7">
                  <c:v>0.40198607283747506</c:v>
                </c:pt>
                <c:pt idx="8">
                  <c:v>0.55219950594387324</c:v>
                </c:pt>
                <c:pt idx="9">
                  <c:v>0.6015375174816483</c:v>
                </c:pt>
                <c:pt idx="1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D57-394B-995B-517344EDA9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57456240"/>
        <c:axId val="1757457328"/>
      </c:barChart>
      <c:catAx>
        <c:axId val="175745624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7328"/>
        <c:crosses val="autoZero"/>
        <c:auto val="1"/>
        <c:lblAlgn val="ctr"/>
        <c:lblOffset val="100"/>
        <c:noMultiLvlLbl val="0"/>
      </c:catAx>
      <c:valAx>
        <c:axId val="1757457328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56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/>
              <a:t>when time window changed 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99:$C$107</c:f>
              <c:strCache>
                <c:ptCount val="9"/>
                <c:pt idx="0">
                  <c:v>Kidney failure or kidney replacement therapy receipt within 3 days</c:v>
                </c:pt>
                <c:pt idx="1">
                  <c:v>NYHA Class IV (vs Class II)</c:v>
                </c:pt>
                <c:pt idx="2">
                  <c:v>Body mass index decrease</c:v>
                </c:pt>
                <c:pt idx="3">
                  <c:v>Failure to initiate enteral alimentation within 3 days</c:v>
                </c:pt>
                <c:pt idx="4">
                  <c:v>Vasopressor use within 3 days</c:v>
                </c:pt>
                <c:pt idx="5">
                  <c:v>Impaired consciousness</c:v>
                </c:pt>
                <c:pt idx="6">
                  <c:v>Absence of comorbid hypertension</c:v>
                </c:pt>
                <c:pt idx="7">
                  <c:v>Age increase</c:v>
                </c:pt>
                <c:pt idx="8">
                  <c:v>Barthel index decrease</c:v>
                </c:pt>
              </c:strCache>
            </c:strRef>
          </c:cat>
          <c:val>
            <c:numRef>
              <c:f>Variableimp!$D$99:$D$107</c:f>
              <c:numCache>
                <c:formatCode>General</c:formatCode>
                <c:ptCount val="9"/>
                <c:pt idx="0">
                  <c:v>1.6559495183933726E-2</c:v>
                </c:pt>
                <c:pt idx="1">
                  <c:v>0.16692656205149045</c:v>
                </c:pt>
                <c:pt idx="2">
                  <c:v>0.17733501118922471</c:v>
                </c:pt>
                <c:pt idx="3">
                  <c:v>0.26782410685715918</c:v>
                </c:pt>
                <c:pt idx="4">
                  <c:v>0.27931005565857064</c:v>
                </c:pt>
                <c:pt idx="5">
                  <c:v>0.30713478069094252</c:v>
                </c:pt>
                <c:pt idx="6">
                  <c:v>0.47612313442194665</c:v>
                </c:pt>
                <c:pt idx="7">
                  <c:v>0.81144612210328548</c:v>
                </c:pt>
                <c:pt idx="8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537-8748-81DA-5C439F5874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57448624"/>
        <c:axId val="1757449168"/>
      </c:barChart>
      <c:catAx>
        <c:axId val="17574486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49168"/>
        <c:crosses val="autoZero"/>
        <c:auto val="1"/>
        <c:lblAlgn val="ctr"/>
        <c:lblOffset val="100"/>
        <c:noMultiLvlLbl val="0"/>
      </c:catAx>
      <c:valAx>
        <c:axId val="1757449168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7448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b="0" i="0" u="none" strike="noStrike" baseline="0">
                <a:effectLst/>
              </a:rPr>
              <a:t>Variable importance of the variables selected by 1 standard-error rule of Lasso regression when regarding patients with length of stay ≥ 30 days as those undergoing non-home discharge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109:$C$125</c:f>
              <c:strCache>
                <c:ptCount val="17"/>
                <c:pt idx="0">
                  <c:v>Ischemic heart disease</c:v>
                </c:pt>
                <c:pt idx="1">
                  <c:v>Shock or ventricular fibrillation on admission</c:v>
                </c:pt>
                <c:pt idx="2">
                  <c:v>Admission on weekends or holidays</c:v>
                </c:pt>
                <c:pt idx="3">
                  <c:v>With readmission history for heart failure within previous 30 days</c:v>
                </c:pt>
                <c:pt idx="4">
                  <c:v>Failure to initiate rehabilitation within 2 days </c:v>
                </c:pt>
                <c:pt idx="5">
                  <c:v>Anemia on admission or transfusion within 2 days</c:v>
                </c:pt>
                <c:pt idx="6">
                  <c:v>Female</c:v>
                </c:pt>
                <c:pt idx="7">
                  <c:v>Charlson comorbidity index</c:v>
                </c:pt>
                <c:pt idx="8">
                  <c:v>Body mass index decrease</c:v>
                </c:pt>
                <c:pt idx="9">
                  <c:v>Kidney failure or kidney replacement therapy receipt within 2 days</c:v>
                </c:pt>
                <c:pt idx="10">
                  <c:v>NYHA Class IV (vs Class II)</c:v>
                </c:pt>
                <c:pt idx="11">
                  <c:v>Impaired consciousness</c:v>
                </c:pt>
                <c:pt idx="12">
                  <c:v>Failure to initiate enteral alimentation within 2 days</c:v>
                </c:pt>
                <c:pt idx="13">
                  <c:v>Vasopressor use within 2 days</c:v>
                </c:pt>
                <c:pt idx="14">
                  <c:v>Age increase</c:v>
                </c:pt>
                <c:pt idx="15">
                  <c:v>Absence of comorbid hypertension</c:v>
                </c:pt>
                <c:pt idx="16">
                  <c:v>Barthel index decrease</c:v>
                </c:pt>
              </c:strCache>
            </c:strRef>
          </c:cat>
          <c:val>
            <c:numRef>
              <c:f>Variableimp!$D$109:$D$125</c:f>
              <c:numCache>
                <c:formatCode>General</c:formatCode>
                <c:ptCount val="17"/>
                <c:pt idx="0">
                  <c:v>3.143043080585186E-3</c:v>
                </c:pt>
                <c:pt idx="1">
                  <c:v>3.3696866478812961E-3</c:v>
                </c:pt>
                <c:pt idx="2">
                  <c:v>4.6507614565885688E-3</c:v>
                </c:pt>
                <c:pt idx="3">
                  <c:v>8.2914112622420513E-3</c:v>
                </c:pt>
                <c:pt idx="4">
                  <c:v>2.20845201182133E-2</c:v>
                </c:pt>
                <c:pt idx="5">
                  <c:v>2.3589511134802774E-2</c:v>
                </c:pt>
                <c:pt idx="6">
                  <c:v>5.6202286338578281E-2</c:v>
                </c:pt>
                <c:pt idx="7">
                  <c:v>0.15654408924792756</c:v>
                </c:pt>
                <c:pt idx="8">
                  <c:v>0.17690747511599883</c:v>
                </c:pt>
                <c:pt idx="9">
                  <c:v>0.19922992325108332</c:v>
                </c:pt>
                <c:pt idx="10">
                  <c:v>0.27344832767014193</c:v>
                </c:pt>
                <c:pt idx="11">
                  <c:v>0.29313144191639812</c:v>
                </c:pt>
                <c:pt idx="12">
                  <c:v>0.49576613247582418</c:v>
                </c:pt>
                <c:pt idx="13">
                  <c:v>0.6043753458845732</c:v>
                </c:pt>
                <c:pt idx="14">
                  <c:v>0.635206098539291</c:v>
                </c:pt>
                <c:pt idx="15">
                  <c:v>0.69374890245091081</c:v>
                </c:pt>
                <c:pt idx="16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35D-B148-A6FA-495DFAA56C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81993664"/>
        <c:axId val="1761633088"/>
      </c:barChart>
      <c:catAx>
        <c:axId val="16819936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633088"/>
        <c:crosses val="autoZero"/>
        <c:auto val="1"/>
        <c:lblAlgn val="ctr"/>
        <c:lblOffset val="100"/>
        <c:noMultiLvlLbl val="0"/>
      </c:catAx>
      <c:valAx>
        <c:axId val="1761633088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1993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ja-JP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b="0" i="0" u="none" strike="noStrike" baseline="0">
                <a:effectLst/>
              </a:rPr>
              <a:t>Variable importance of variables selected by 1 standard-error rule of Lasso regression </a:t>
            </a:r>
            <a:r>
              <a:rPr lang="en-US"/>
              <a:t>when excluding those undergoing in-hospital deaths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ja-JP"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ariableimp!$C$127:$C$132</c:f>
              <c:strCache>
                <c:ptCount val="6"/>
                <c:pt idx="0">
                  <c:v>Failure to initiate enteral alimentation within 2 days</c:v>
                </c:pt>
                <c:pt idx="1">
                  <c:v>Body mass index decrease</c:v>
                </c:pt>
                <c:pt idx="2">
                  <c:v>Impaired consciousness</c:v>
                </c:pt>
                <c:pt idx="3">
                  <c:v>Absence of comorbid hypertension</c:v>
                </c:pt>
                <c:pt idx="4">
                  <c:v>Age increase</c:v>
                </c:pt>
                <c:pt idx="5">
                  <c:v>Barthel index decrease</c:v>
                </c:pt>
              </c:strCache>
            </c:strRef>
          </c:cat>
          <c:val>
            <c:numRef>
              <c:f>Variableimp!$D$127:$D$132</c:f>
              <c:numCache>
                <c:formatCode>General</c:formatCode>
                <c:ptCount val="6"/>
                <c:pt idx="0">
                  <c:v>0.10914479308535791</c:v>
                </c:pt>
                <c:pt idx="1">
                  <c:v>0.13798041896451937</c:v>
                </c:pt>
                <c:pt idx="2">
                  <c:v>0.31302860401908822</c:v>
                </c:pt>
                <c:pt idx="3">
                  <c:v>0.31710737698042551</c:v>
                </c:pt>
                <c:pt idx="4">
                  <c:v>0.70060954421961241</c:v>
                </c:pt>
                <c:pt idx="5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9D5-E248-B858-9AEC9D3709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61634720"/>
        <c:axId val="1761633632"/>
      </c:barChart>
      <c:catAx>
        <c:axId val="17616347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633632"/>
        <c:crosses val="autoZero"/>
        <c:auto val="1"/>
        <c:lblAlgn val="ctr"/>
        <c:lblOffset val="100"/>
        <c:noMultiLvlLbl val="0"/>
      </c:catAx>
      <c:valAx>
        <c:axId val="1761633632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61634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D5319B3-530F-E186-AAFC-96007A948B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A93AA4BA-419F-E902-838C-AF96127D88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AB3E6D6-01A5-E7E9-7D4E-41BCF51AC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21C8614-8390-A699-88AC-D94F3E688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816C96F-67EC-C133-8044-29F30842F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6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5DA78D1-31BC-2F08-CC5E-0C3DAF55B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212A7732-7F5A-4503-E3AC-C3A3E13E4E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A7B5916-C32E-9797-C4AF-0C7337B1C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DC20597-F55B-6D6F-89BF-3B2E57E2D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909AA09-F157-82BD-DD71-BFE19A4C3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042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75216067-FE4C-9E47-354B-BE872423D5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7805B607-62E8-AECE-5132-774B3E2CB5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C5490D6-578E-57BA-4138-45A938CF6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E93D915-7231-D4AD-211C-5E4881A6A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E0DE908-E889-95DD-6802-B1F7E9A51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0329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F82E563-46D4-C9BA-9CC5-819C6D254A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B5CFD8FF-F834-5C95-1BAF-334A841555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86DEA1B-3025-DF40-6949-C8735755D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F16478F-C272-DA8C-5F8E-3FD94BD5C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E3EC8CE-D455-E438-B784-9CAFCAE41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8095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1D80AD6-3B2F-7679-30FA-43DD20FD2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C4D8C42-2A11-AB50-DDEC-25B98BA40B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10C2342-D3A2-C4AB-AC49-D93089816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E38352B-F7B4-8E9A-0A26-FF9CFEA05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EFC1397-AB92-0886-5398-82523EBC9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377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DB65753-D6FC-3C0A-60B7-8E2EFC43C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85DE3935-2016-D2C1-34D8-E509605980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78B345D7-8DF7-C66C-5098-84C7544EF0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969D4683-8640-FC31-B621-E021C94B5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D2D1AE73-5ECE-8ACF-AE5B-1A3E491C8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177A0A01-6B08-47F1-6225-A44B13F81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676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7F5B3E7-0960-EB33-F2FE-26929F205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B1B7F18-EBCB-A45D-AF8E-2F084C92E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B6636A98-4312-5FEA-F4BF-5B6FC076EB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BA1D8A05-4126-E78E-2036-E181FB5144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A903D8D5-7E11-A4F7-2619-EE725CD8E7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BDE783C2-605F-620D-834B-058127A8C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9F997B2E-8DA3-0081-A5CF-9FA5288AF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0599A258-1B27-EC58-21ED-876792EB8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422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2C6F12D-CE5F-5BDE-7FC8-61C34DBD6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3B6A00B2-43C2-1F4A-C367-D72A93E37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831F74CF-69E0-B080-BCEE-7B7458059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181F77F4-5357-8B9B-2A39-E7B8A97F2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0286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5EF24AA3-4681-D61A-EFB7-7CF92B834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4A1A78EE-D58D-3DBA-7A86-05AC500653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B6DD4F18-47CA-BEC5-B71F-C08D3281B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466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416B2C8-838C-FD6C-4F30-7E7D9D5FC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A5262EB6-04F7-D564-6D42-A8F7D53010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C7169147-355B-1B6E-3B40-28F54DB570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93C0E3F-99D0-8300-31E5-FC09282F9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42A90AAD-D37C-6636-9C85-BA0D74B9A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DA59293-E66D-E0ED-F0FF-9D603E96A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626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28D524A-B401-08AC-2DF5-40AB6BFF5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3BD3018E-2805-24F5-8B6E-E14DBB3D13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8B3D40E7-DBF7-761B-C79F-523CC14611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0D6238C-75DE-FB0C-3866-79848E0EC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43D31B20-692A-82B2-B230-11DE10411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594CB891-DAA8-EBB1-1CF2-AFC31BFF1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845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DE5FA22B-464C-B3AA-3045-CB5F6ABB8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9FBECB3C-61DD-9F41-1CAD-00E8484CB3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C8C5A3F-0545-5971-0627-A2C39809BA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067424-5E3C-744E-9EA8-B3CFC74E9159}" type="datetimeFigureOut">
              <a:rPr kumimoji="1" lang="ja-JP" altLang="en-US" smtClean="0"/>
              <a:t>2023/4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B0FED72-57B6-8EA3-F5AB-E7F4FC7DD1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1A92B10-263D-E165-6FF8-FF2E07D764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9278E-3B05-AF45-8B38-FE1DB62B4D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853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92BC3A7C-8151-FD1A-CB94-6CB0BA9DEA97}"/>
              </a:ext>
            </a:extLst>
          </p:cNvPr>
          <p:cNvSpPr txBox="1"/>
          <p:nvPr/>
        </p:nvSpPr>
        <p:spPr>
          <a:xfrm>
            <a:off x="92489" y="43613"/>
            <a:ext cx="120995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. Part of STATA commands used in the main analysi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1F8B0C47-3F02-9A4A-5349-14654D186CE7}"/>
              </a:ext>
            </a:extLst>
          </p:cNvPr>
          <p:cNvSpPr txBox="1"/>
          <p:nvPr/>
        </p:nvSpPr>
        <p:spPr>
          <a:xfrm>
            <a:off x="200722" y="443723"/>
            <a:ext cx="11541512" cy="65043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lear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use "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ataset.dt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"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Split the dataset into 2 types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plitsampl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, gen(sample) split(.8 .2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seed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"insert here some seed")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abel define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label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 "Training" 2 "Validation"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abel values sample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label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Lasso regression using 1SE rule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asso logit outcome var1 var2 ...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ar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if sample ==1,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seed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"insert here some seed"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alllambda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selection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cv,serul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edict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nes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stimates store cv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nese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Show information regarding variable importance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trix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e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b_standardized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atrix list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coefpath,titl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"Coefficient paths") legend(cols(8) row(2) ring(0) pos(4) size(tiny) color(navy) stack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xunit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lnlambda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 name(fig1,replace)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cvplot,s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name(fig2,replace)</a:t>
            </a:r>
          </a:p>
          <a:p>
            <a:pPr>
              <a:lnSpc>
                <a:spcPts val="1000"/>
              </a:lnSpc>
            </a:pP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Logistic regression using all variables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gistic outcome var1 var2 ...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ar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if sample ==1,base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edict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ls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Calibration of the model using all variables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mcalplot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l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outcome if sample==2,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nospik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subtitle("Model using all candidate variables"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xtitl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"Predicted probability"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ytitl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"Observed frequency") legend( ring(0) pos(5) col(1)) name(Fig3,replace)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Logistic regression using the variables selected by 1SE rule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gistic outcome selectedvar1 selectedvar2 ...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electedvar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if sample ==1,base</a:t>
            </a: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edict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nesel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Calibration using the variables selected by 1SE rule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mcalplot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nesel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outcome if sample==2,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nospik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subtitle("Model using 1SE-selected variables"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xtitl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"Predicted probability"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ytitl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"Observed frequency") legend( ring(0) pos(5) col(1)) name(Fig4,replace)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Combine the graphs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graph combine Fig3 Fig4,title("Calibration of predictive models") subtitle("Primary analysis") name(Fig5,replace)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Comparison of ROC curves and C-statistic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occom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outcome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nesel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ol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if sample==2, graph summary name(Fig6,replace) plot1opts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lwidth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edthi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siz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zero)) plot2opts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lwidth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edthi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size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zero)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rlopt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lwidth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thi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lpattern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dot)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lcolo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gs8)) title("Comparison of discriminative abilities") subtitle("Primary analysis") legend(order(1 "Model using 1SE-selected variables" 2 "Model using all candidate variables") ring(0) pos(5) col(1))</a:t>
            </a: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17576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FA35B46E-7171-70A7-DA80-4BC29FD764CC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0. Variable importance of the variables selected by 1 standard-error rule of Lasso regression among patients with Barthel index ≥ 60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26B8B95C-1BA5-8C4F-A1F5-BD65AE604A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0909925"/>
              </p:ext>
            </p:extLst>
          </p:nvPr>
        </p:nvGraphicFramePr>
        <p:xfrm>
          <a:off x="2" y="751499"/>
          <a:ext cx="12191998" cy="60628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778567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7AC37E93-22AA-95D2-A200-E1A5920D6D75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1. Variable importance of the variables selected by 1 standard-error rule of Lasso regression among patients with Barthel index &lt; 60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924CFF75-3F63-3E4F-877D-9269FB4C4A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0130492"/>
              </p:ext>
            </p:extLst>
          </p:nvPr>
        </p:nvGraphicFramePr>
        <p:xfrm>
          <a:off x="0" y="751499"/>
          <a:ext cx="12192000" cy="610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996873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2. Receiver operating characteristic curve and calibration when analyzed when analyzed among patients with Barthel index ≥60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5" name="図 4" descr="グラフ, 折れ線グラフ&#10;&#10;自動的に生成された説明">
            <a:extLst>
              <a:ext uri="{FF2B5EF4-FFF2-40B4-BE49-F238E27FC236}">
                <a16:creationId xmlns:a16="http://schemas.microsoft.com/office/drawing/2014/main" xmlns="" id="{C105E085-369D-3D80-2546-55EB5726B1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63650"/>
            <a:ext cx="11282400" cy="442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891116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3. Receiver operating characteristic curve and calibration when analyzed when analyzed among patients with Barthel index &lt;60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グラフ, 折れ線グラフ&#10;&#10;自動的に生成された説明">
            <a:extLst>
              <a:ext uri="{FF2B5EF4-FFF2-40B4-BE49-F238E27FC236}">
                <a16:creationId xmlns:a16="http://schemas.microsoft.com/office/drawing/2014/main" xmlns="" id="{FC83ACE1-C4AD-7590-00C1-ADE94ABE54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63650"/>
            <a:ext cx="11282400" cy="442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379515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3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4. Flowchart in sensitivity analysis 2, when time window was changed from 2 days to 3 days (sensitivity analysis 1)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EE3C7134-8C1B-4CC8-DA3D-A7CABECFFA05}"/>
              </a:ext>
            </a:extLst>
          </p:cNvPr>
          <p:cNvSpPr txBox="1"/>
          <p:nvPr/>
        </p:nvSpPr>
        <p:spPr>
          <a:xfrm>
            <a:off x="136060" y="777625"/>
            <a:ext cx="11283528" cy="2189510"/>
          </a:xfrm>
          <a:prstGeom prst="rect">
            <a:avLst/>
          </a:prstGeom>
          <a:ln w="285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 algn="ctr">
              <a:lnSpc>
                <a:spcPct val="150000"/>
              </a:lnSpc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 extraction: discharges recorded in the Diagnosis Procedure Combination database </a:t>
            </a:r>
          </a:p>
          <a:p>
            <a:pPr algn="ctr">
              <a:lnSpc>
                <a:spcPct val="150000"/>
              </a:lnSpc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lusion criteria (n =170,007)</a:t>
            </a:r>
          </a:p>
          <a:p>
            <a:pPr lvl="0" algn="ctr">
              <a:lnSpc>
                <a:spcPct val="150000"/>
              </a:lnSpc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iod: from April 2014 to March 2018</a:t>
            </a:r>
          </a:p>
          <a:p>
            <a:pPr lvl="0" algn="ctr">
              <a:lnSpc>
                <a:spcPct val="150000"/>
              </a:lnSpc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mission type: Unscheduled admission not from nursery facility or hospital</a:t>
            </a:r>
          </a:p>
          <a:p>
            <a:pPr lvl="0" algn="ctr">
              <a:lnSpc>
                <a:spcPct val="150000"/>
              </a:lnSpc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	Purpose of admission: treatment of acute heart failure (NYHA grade ≥ II 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EA64033-7443-2F1A-279B-019E7502AF9E}"/>
              </a:ext>
            </a:extLst>
          </p:cNvPr>
          <p:cNvSpPr txBox="1"/>
          <p:nvPr/>
        </p:nvSpPr>
        <p:spPr>
          <a:xfrm>
            <a:off x="3556054" y="6298625"/>
            <a:ext cx="5242560" cy="456535"/>
          </a:xfrm>
          <a:prstGeom prst="rect">
            <a:avLst/>
          </a:prstGeom>
          <a:noFill/>
          <a:ln w="285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t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nalyzed in this study (n =126,923)</a:t>
            </a: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xmlns="" id="{012E0A9D-6FBE-27E2-7AE4-3169DBA4DCF8}"/>
              </a:ext>
            </a:extLst>
          </p:cNvPr>
          <p:cNvCxnSpPr>
            <a:cxnSpLocks/>
          </p:cNvCxnSpPr>
          <p:nvPr/>
        </p:nvCxnSpPr>
        <p:spPr>
          <a:xfrm>
            <a:off x="4443587" y="2931644"/>
            <a:ext cx="0" cy="33669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2B6E653B-AD71-C66A-636C-97641D338B25}"/>
              </a:ext>
            </a:extLst>
          </p:cNvPr>
          <p:cNvSpPr txBox="1"/>
          <p:nvPr/>
        </p:nvSpPr>
        <p:spPr>
          <a:xfrm>
            <a:off x="5224878" y="3637085"/>
            <a:ext cx="6194711" cy="369332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 &lt; 20 years (n =32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8DFA0D54-9CD7-D42A-C8E9-B813DEE21DE4}"/>
              </a:ext>
            </a:extLst>
          </p:cNvPr>
          <p:cNvSpPr txBox="1"/>
          <p:nvPr/>
        </p:nvSpPr>
        <p:spPr>
          <a:xfrm>
            <a:off x="5224878" y="4295374"/>
            <a:ext cx="6194711" cy="369332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ngth of stay &lt; 4 days (n =4,002)</a:t>
            </a: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xmlns="" id="{F6407F8A-AA97-CE30-B438-3799B8EE3E33}"/>
              </a:ext>
            </a:extLst>
          </p:cNvPr>
          <p:cNvCxnSpPr/>
          <p:nvPr/>
        </p:nvCxnSpPr>
        <p:spPr>
          <a:xfrm>
            <a:off x="4452411" y="3840175"/>
            <a:ext cx="741871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xmlns="" id="{B0083CFF-74D1-614E-BCC3-DD7403A07063}"/>
              </a:ext>
            </a:extLst>
          </p:cNvPr>
          <p:cNvCxnSpPr/>
          <p:nvPr/>
        </p:nvCxnSpPr>
        <p:spPr>
          <a:xfrm>
            <a:off x="4452411" y="4488770"/>
            <a:ext cx="741871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EC93CD1A-17BE-BC4F-C3D3-2EC82E0D4F88}"/>
              </a:ext>
            </a:extLst>
          </p:cNvPr>
          <p:cNvSpPr txBox="1"/>
          <p:nvPr/>
        </p:nvSpPr>
        <p:spPr>
          <a:xfrm>
            <a:off x="5228418" y="5038296"/>
            <a:ext cx="6191170" cy="923330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ing data on</a:t>
            </a:r>
          </a:p>
          <a:p>
            <a:pPr marL="285751" indent="-285751">
              <a:buFont typeface="Arial" panose="020B0604020202020204" pitchFamily="34" charset="0"/>
              <a:buChar char="•"/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dy mass index (n =12,094) </a:t>
            </a:r>
          </a:p>
          <a:p>
            <a:pPr marL="285751" indent="-285751">
              <a:buFont typeface="Arial" panose="020B0604020202020204" pitchFamily="34" charset="0"/>
              <a:buChar char="•"/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thel index (n =26,822) </a:t>
            </a: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xmlns="" id="{B863759E-C5A8-5E84-CA1F-F9134F9F36F8}"/>
              </a:ext>
            </a:extLst>
          </p:cNvPr>
          <p:cNvCxnSpPr/>
          <p:nvPr/>
        </p:nvCxnSpPr>
        <p:spPr>
          <a:xfrm>
            <a:off x="4455952" y="5533748"/>
            <a:ext cx="741871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FA25DC79-4E8E-8646-A601-489E4DC45AAE}"/>
              </a:ext>
            </a:extLst>
          </p:cNvPr>
          <p:cNvSpPr txBox="1"/>
          <p:nvPr/>
        </p:nvSpPr>
        <p:spPr>
          <a:xfrm>
            <a:off x="5236348" y="3090385"/>
            <a:ext cx="6194711" cy="369332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>
            <a:spAutoFit/>
          </a:bodyPr>
          <a:lstStyle/>
          <a:p>
            <a:pPr lvl="0">
              <a:defRPr/>
            </a:pPr>
            <a:r>
              <a:rPr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ing information on discharge details (n </a:t>
            </a:r>
            <a:r>
              <a:rPr lang="en-US" altLang="ja-JP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134)</a:t>
            </a:r>
            <a:endParaRPr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xmlns="" id="{416B9F66-D749-8499-2F98-98EB15F4B386}"/>
              </a:ext>
            </a:extLst>
          </p:cNvPr>
          <p:cNvCxnSpPr/>
          <p:nvPr/>
        </p:nvCxnSpPr>
        <p:spPr>
          <a:xfrm>
            <a:off x="4463881" y="3293475"/>
            <a:ext cx="741871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7036516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5. Variable importance of the variables selected by 1 standard-error rule of Lasso regression when time window was changed from 2 days to 3 days (sensitivity analysis 1)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07157854-DD89-9C46-9F39-6F9C6C5183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8971610"/>
              </p:ext>
            </p:extLst>
          </p:nvPr>
        </p:nvGraphicFramePr>
        <p:xfrm>
          <a:off x="0" y="751499"/>
          <a:ext cx="12192000" cy="610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923416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6. Receiver operating characteristic curve and calibration when analyzed when time window was changed from 2 days to 3 days (sensitivity analysis 1)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グラフ, 折れ線グラフ&#10;&#10;自動的に生成された説明">
            <a:extLst>
              <a:ext uri="{FF2B5EF4-FFF2-40B4-BE49-F238E27FC236}">
                <a16:creationId xmlns:a16="http://schemas.microsoft.com/office/drawing/2014/main" xmlns="" id="{2F2C98BF-E5E3-0BE9-9D84-2413CCBB10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63650"/>
            <a:ext cx="11282400" cy="442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39315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7. Variable importance of the variables selected by 1 standard-error rule of Lasso regression when regarding patients with length of stay ≥ 30 days as those undergoing non-home discharge (sensitivity analysis 2)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7BEEC9DD-F18E-984B-A197-B0627229A6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8820934"/>
              </p:ext>
            </p:extLst>
          </p:nvPr>
        </p:nvGraphicFramePr>
        <p:xfrm>
          <a:off x="0" y="1059276"/>
          <a:ext cx="12192000" cy="5798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8261716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8. Receiver operating characteristic curve and calibration when analyzed when regarding patients with length of stay ≥ 30 days as those undergoing non-home discharge (sensitivity analysis 2)</a:t>
            </a:r>
            <a:endParaRPr lang="ja-JP" altLang="en-US" sz="2000" b="1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  <a:p>
            <a:pPr lvl="0">
              <a:defRPr/>
            </a:pP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グラフ&#10;&#10;自動的に生成された説明">
            <a:extLst>
              <a:ext uri="{FF2B5EF4-FFF2-40B4-BE49-F238E27FC236}">
                <a16:creationId xmlns:a16="http://schemas.microsoft.com/office/drawing/2014/main" xmlns="" id="{FE0B562F-B130-EC13-34F6-BF4DD1B19B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57299"/>
            <a:ext cx="11282400" cy="4435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32054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19. Variable importance of the variables selected by 1 standard-error rule of Lasso regression when excluding those undergoing in-hospital deaths (sensitivity analysis 3)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FC4B0389-350A-A94A-AA1B-228A0B9618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9655721"/>
              </p:ext>
            </p:extLst>
          </p:nvPr>
        </p:nvGraphicFramePr>
        <p:xfrm>
          <a:off x="0" y="751499"/>
          <a:ext cx="12192000" cy="610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58911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92BC3A7C-8151-FD1A-CB94-6CB0BA9DEA97}"/>
              </a:ext>
            </a:extLst>
          </p:cNvPr>
          <p:cNvSpPr txBox="1"/>
          <p:nvPr/>
        </p:nvSpPr>
        <p:spPr>
          <a:xfrm>
            <a:off x="92489" y="43613"/>
            <a:ext cx="120995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2. Variable importance of the variables selected by 1 standard-error rule of Lasso regression among patients aged ≥ 80 year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xmlns="" id="{18E76318-DE34-7A46-A9CE-E4A63C7A7764}"/>
              </a:ext>
            </a:extLst>
          </p:cNvPr>
          <p:cNvGraphicFramePr>
            <a:graphicFrameLocks/>
          </p:cNvGraphicFramePr>
          <p:nvPr/>
        </p:nvGraphicFramePr>
        <p:xfrm>
          <a:off x="0" y="751499"/>
          <a:ext cx="12192000" cy="610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3252095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20. Receiver operating characteristic curve and calibration when analyzed when excluding those undergoing in-hospital deaths (sensitivity analysis 3)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グラフ, 折れ線グラフ&#10;&#10;自動的に生成された説明">
            <a:extLst>
              <a:ext uri="{FF2B5EF4-FFF2-40B4-BE49-F238E27FC236}">
                <a16:creationId xmlns:a16="http://schemas.microsoft.com/office/drawing/2014/main" xmlns="" id="{BC82451E-E1CD-9628-464C-701D208DDC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63650"/>
            <a:ext cx="11282400" cy="442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87738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92BC3A7C-8151-FD1A-CB94-6CB0BA9DEA97}"/>
              </a:ext>
            </a:extLst>
          </p:cNvPr>
          <p:cNvSpPr txBox="1"/>
          <p:nvPr/>
        </p:nvSpPr>
        <p:spPr>
          <a:xfrm>
            <a:off x="92489" y="43613"/>
            <a:ext cx="120995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3. Variable importance of the variables selected by 1 standard-error rule of Lasso regression among patients aged &lt; 80 year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124DB3D5-B488-B94B-B2C2-FEB75024B9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3474916"/>
              </p:ext>
            </p:extLst>
          </p:nvPr>
        </p:nvGraphicFramePr>
        <p:xfrm>
          <a:off x="0" y="751499"/>
          <a:ext cx="12192000" cy="610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62116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1C99DCC1-BEBE-29BB-B9A3-CB9A6628CF04}"/>
              </a:ext>
            </a:extLst>
          </p:cNvPr>
          <p:cNvSpPr txBox="1"/>
          <p:nvPr/>
        </p:nvSpPr>
        <p:spPr>
          <a:xfrm>
            <a:off x="92489" y="-23961"/>
            <a:ext cx="120995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4. Receiver operating characteristic curve and calibration when analyzed among those aged ≥ 80 year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グラフ, 折れ線グラフ&#10;&#10;自動的に生成された説明">
            <a:extLst>
              <a:ext uri="{FF2B5EF4-FFF2-40B4-BE49-F238E27FC236}">
                <a16:creationId xmlns:a16="http://schemas.microsoft.com/office/drawing/2014/main" xmlns="" id="{1C76933C-5D94-3C4D-4CCB-FD20DFC8E3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63650"/>
            <a:ext cx="11282400" cy="442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68095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1C99DCC1-BEBE-29BB-B9A3-CB9A6628CF04}"/>
              </a:ext>
            </a:extLst>
          </p:cNvPr>
          <p:cNvSpPr txBox="1"/>
          <p:nvPr/>
        </p:nvSpPr>
        <p:spPr>
          <a:xfrm>
            <a:off x="92489" y="-23961"/>
            <a:ext cx="120995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5. Receiver operating characteristic curve and calibration when analyzed among those aged &lt; 80 year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グラフ, 散布図&#10;&#10;自動的に生成された説明">
            <a:extLst>
              <a:ext uri="{FF2B5EF4-FFF2-40B4-BE49-F238E27FC236}">
                <a16:creationId xmlns:a16="http://schemas.microsoft.com/office/drawing/2014/main" xmlns="" id="{0005B69E-E0D2-C07E-DEBF-BD7A0EEAE4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63650"/>
            <a:ext cx="11282400" cy="442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88620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FA35B46E-7171-70A7-DA80-4BC29FD764CC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6. Variable importance of the variables selected by 1 standard-error rule of Lasso regression among female patient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C775DF3F-24DE-1D42-99EE-0060F54B65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1244831"/>
              </p:ext>
            </p:extLst>
          </p:nvPr>
        </p:nvGraphicFramePr>
        <p:xfrm>
          <a:off x="0" y="751499"/>
          <a:ext cx="12192000" cy="610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003183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7AC37E93-22AA-95D2-A200-E1A5920D6D75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7. Variable importance of the variables selected by 1 standard-error rule of Lasso regression among male patient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DD1256C8-2FCE-1348-A811-A1F95A4827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3320641"/>
              </p:ext>
            </p:extLst>
          </p:nvPr>
        </p:nvGraphicFramePr>
        <p:xfrm>
          <a:off x="0" y="751499"/>
          <a:ext cx="12192000" cy="6106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220918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8. Receiver operating characteristic curve and calibration when analyzed when analyzed among female patient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5" name="図 4" descr="グラフ, 折れ線グラフ&#10;&#10;自動的に生成された説明">
            <a:extLst>
              <a:ext uri="{FF2B5EF4-FFF2-40B4-BE49-F238E27FC236}">
                <a16:creationId xmlns:a16="http://schemas.microsoft.com/office/drawing/2014/main" xmlns="" id="{CA2CE39F-BB94-78E0-113E-28DD6C080E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57299"/>
            <a:ext cx="11282400" cy="4435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662534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3C0619AD-8F16-002B-7E48-D5873F6126C1}"/>
              </a:ext>
            </a:extLst>
          </p:cNvPr>
          <p:cNvSpPr txBox="1"/>
          <p:nvPr/>
        </p:nvSpPr>
        <p:spPr>
          <a:xfrm>
            <a:off x="92489" y="43613"/>
            <a:ext cx="120025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b="1" dirty="0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9. Receiver operating characteristic curve and calibration when analyzed when analyzed among </a:t>
            </a:r>
            <a:r>
              <a:rPr lang="en-US" altLang="ja-JP" sz="2000" b="1"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ale patients</a:t>
            </a:r>
            <a:endParaRPr lang="ja-JP" altLang="en-US" sz="2000" b="1" dirty="0"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グラフ&#10;&#10;自動的に生成された説明">
            <a:extLst>
              <a:ext uri="{FF2B5EF4-FFF2-40B4-BE49-F238E27FC236}">
                <a16:creationId xmlns:a16="http://schemas.microsoft.com/office/drawing/2014/main" xmlns="" id="{6E4D38E7-E408-6C75-37EB-1BA9253630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" y="1263650"/>
            <a:ext cx="11282400" cy="442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1070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3</TotalTime>
  <Words>1063</Words>
  <Application>Microsoft Office PowerPoint</Application>
  <PresentationFormat>Widescreen</PresentationFormat>
  <Paragraphs>88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游ゴシック</vt:lpstr>
      <vt:lpstr>游ゴシック Light</vt:lpstr>
      <vt:lpstr>Arial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田 啓</dc:creator>
  <cp:lastModifiedBy>Jeeva B.</cp:lastModifiedBy>
  <cp:revision>123</cp:revision>
  <dcterms:created xsi:type="dcterms:W3CDTF">2022-05-30T00:24:42Z</dcterms:created>
  <dcterms:modified xsi:type="dcterms:W3CDTF">2023-04-20T16:26:26Z</dcterms:modified>
</cp:coreProperties>
</file>